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FA2C35-B561-48DF-B211-90E51B3852B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0A570B-41F4-4569-8C5C-C9612B1FCE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1A171D-8D49-4004-8B6A-7D25685AC9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C5912C-C5E1-4BF0-8A2B-7932C680834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82C6DBB9-D859-46B5-9303-C2A2EAD01F65}" type="slidenum">
              <a:t>&lt;#&gt;</a:t>
            </a:fld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F38B07C0-5C24-4E72-9F5B-D8466495E8D7}" type="slidenum">
              <a:t>&lt;#&gt;</a:t>
            </a:fld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6BBF9885-AC7E-42A8-B2BD-93CF3F270FEC}" type="slidenum">
              <a:t>&lt;#&gt;</a:t>
            </a:fld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FCCBAFEA-DF8F-4D05-B341-87F7E02CE7B1}" type="slidenum">
              <a:t>&lt;#&gt;</a:t>
            </a:fld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D67E1D47-09CE-4F60-8A8F-82A344834D18}" type="slidenum">
              <a:t>&lt;#&gt;</a:t>
            </a:fld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52C80336-CE5F-44B9-8365-AD69DB559E07}" type="slidenum">
              <a:t>&lt;#&gt;</a:t>
            </a:fld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F236D658-33A6-41DE-B800-AFDEB68F5494}" type="slidenum">
              <a:t>&lt;#&gt;</a:t>
            </a:fld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2AF2F4-0718-4E2C-B537-E1BBF3B25B9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A523E587-AA57-4199-93D0-E2BD292C79FE}" type="slidenum">
              <a:t>&lt;#&gt;</a:t>
            </a:fld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84E3D09E-B155-471F-8D69-57446B991368}" type="slidenum">
              <a:t>&lt;#&gt;</a:t>
            </a:fld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66928B0F-38AA-4575-B450-39E1DE745DB2}" type="slidenum">
              <a:t>&lt;#&gt;</a:t>
            </a:fld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1A33C8D1-626E-48B5-8A2F-1801AFD3F833}" type="slidenum">
              <a:t>&lt;#&gt;</a:t>
            </a:fld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sldNum" idx="4"/>
          </p:nvPr>
        </p:nvSpPr>
        <p:spPr/>
        <p:txBody>
          <a:bodyPr/>
          <a:p>
            <a:fld id="{90DBB818-11A4-402E-ADC9-E2BF42FCFD81}" type="slidenum">
              <a:t>&lt;#&gt;</a:t>
            </a:fld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C63D38-7AC5-4F0A-9D35-10509197A9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F19C24-DE38-45F3-8006-49B2F2579CE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8C3287-FD65-4D25-B67A-DD888CD7EBF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3E774E-0685-4B6E-A23B-CC9E91A37C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FEC5A1-069C-4DAB-949E-767BDC4FE8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F40937-2F76-4F23-B517-0EB643920A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A1272B-774E-45DF-A424-7B2CDD2EDCC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5BD445-DBAA-42DD-91EB-F04939E0DAAB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sldNum" idx="4"/>
          </p:nvPr>
        </p:nvSpPr>
        <p:spPr>
          <a:xfrm>
            <a:off x="8548200" y="6365880"/>
            <a:ext cx="4510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900" spc="-1" strike="noStrike">
                <a:solidFill>
                  <a:srgbClr val="eeece1"/>
                </a:solidFill>
                <a:latin typeface="Verdana"/>
                <a:ea typeface="Verdan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2E8EF4-2FA2-4C02-92FE-9084D2DE8F76}" type="slidenum">
              <a:rPr b="0" lang="en-US" sz="900" spc="-1" strike="noStrike">
                <a:solidFill>
                  <a:srgbClr val="eeece1"/>
                </a:solidFill>
                <a:latin typeface="Verdana"/>
                <a:ea typeface="Verdana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Slide Number Placeholder 1"/>
          <p:cNvSpPr/>
          <p:nvPr/>
        </p:nvSpPr>
        <p:spPr>
          <a:xfrm>
            <a:off x="8548560" y="6365880"/>
            <a:ext cx="451080" cy="365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3EF456D-6419-46A6-B3C2-AF0E657B19ED}" type="slidenum">
              <a:rPr b="0" lang="en-US" sz="900" spc="-1" strike="noStrike">
                <a:solidFill>
                  <a:srgbClr val="eeece1"/>
                </a:solidFill>
                <a:latin typeface="Verdana"/>
                <a:ea typeface="Verdana"/>
              </a:rPr>
              <a:t>&lt;number&gt;</a:t>
            </a:fld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Rectangle 5"/>
          <p:cNvSpPr/>
          <p:nvPr/>
        </p:nvSpPr>
        <p:spPr>
          <a:xfrm>
            <a:off x="1789200" y="3975120"/>
            <a:ext cx="4572000" cy="36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285840" indent="-285840"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82" name="Object 3"/>
          <p:cNvGraphicFramePr/>
          <p:nvPr/>
        </p:nvGraphicFramePr>
        <p:xfrm>
          <a:off x="179280" y="189000"/>
          <a:ext cx="8931240" cy="29527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83" name="Object 3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79280" y="189000"/>
                    <a:ext cx="8931240" cy="2952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84" name=""/>
          <p:cNvGraphicFramePr/>
          <p:nvPr/>
        </p:nvGraphicFramePr>
        <p:xfrm>
          <a:off x="2411280" y="3284640"/>
          <a:ext cx="4321440" cy="952560"/>
        </p:xfrm>
        <a:graphic>
          <a:graphicData uri="http://schemas.openxmlformats.org/drawingml/2006/table">
            <a:tbl>
              <a:tblPr/>
              <a:tblGrid>
                <a:gridCol w="1351080"/>
                <a:gridCol w="1096920"/>
                <a:gridCol w="647640"/>
                <a:gridCol w="1225800"/>
              </a:tblGrid>
              <a:tr h="190440">
                <a:tc gridSpan="4">
                  <a:txBody>
                    <a:bodyPr lIns="9360" rIns="9360" tIns="936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D-Antigen recovery [DU/ml after inactivation] / [DU/ml before inactivation]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pe 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pe 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ype 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AV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3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6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2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440"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bin (n=2)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60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9 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7 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0800">
                <a:tc>
                  <a:txBody>
                    <a:bodyPr lIns="9360" rIns="9360" tIns="936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alk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3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80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9360" rIns="936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nl-NL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7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1-13T15:35:05Z</dcterms:created>
  <dc:creator>Sanders, Barbara [CRXNL]</dc:creator>
  <dc:description/>
  <dc:language>en-US</dc:language>
  <cp:lastModifiedBy>Sanders, Barbara [CRXNL]</cp:lastModifiedBy>
  <dcterms:modified xsi:type="dcterms:W3CDTF">2016-01-14T15:47:34Z</dcterms:modified>
  <cp:revision>14</cp:revision>
  <dc:subject/>
  <dc:title>PowerPoint Presentation</dc:title>
</cp:coreProperties>
</file>